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>
      <p:cViewPr varScale="1">
        <p:scale>
          <a:sx n="87" d="100"/>
          <a:sy n="87" d="100"/>
        </p:scale>
        <p:origin x="3432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D8E3F-741A-6B41-A7B1-39271E608C75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3D436-496B-F747-96EF-21F2B708C4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54144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D8E3F-741A-6B41-A7B1-39271E608C75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3D436-496B-F747-96EF-21F2B708C4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72902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D8E3F-741A-6B41-A7B1-39271E608C75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3D436-496B-F747-96EF-21F2B708C4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35741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D8E3F-741A-6B41-A7B1-39271E608C75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3D436-496B-F747-96EF-21F2B708C4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5779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D8E3F-741A-6B41-A7B1-39271E608C75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3D436-496B-F747-96EF-21F2B708C4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3841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D8E3F-741A-6B41-A7B1-39271E608C75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3D436-496B-F747-96EF-21F2B708C4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2872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D8E3F-741A-6B41-A7B1-39271E608C75}" type="datetimeFigureOut">
              <a:rPr lang="en-US" smtClean="0"/>
              <a:t>6/10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3D436-496B-F747-96EF-21F2B708C4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59128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D8E3F-741A-6B41-A7B1-39271E608C75}" type="datetimeFigureOut">
              <a:rPr lang="en-US" smtClean="0"/>
              <a:t>6/10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3D436-496B-F747-96EF-21F2B708C4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5406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D8E3F-741A-6B41-A7B1-39271E608C75}" type="datetimeFigureOut">
              <a:rPr lang="en-US" smtClean="0"/>
              <a:t>6/10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3D436-496B-F747-96EF-21F2B708C4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3291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D8E3F-741A-6B41-A7B1-39271E608C75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3D436-496B-F747-96EF-21F2B708C4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74137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D8E3F-741A-6B41-A7B1-39271E608C75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3D436-496B-F747-96EF-21F2B708C4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50784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21D8E3F-741A-6B41-A7B1-39271E608C75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833D436-496B-F747-96EF-21F2B708C4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485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EE5AC78-EFD5-5AD6-651A-948208A7BC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6987" y="2853600"/>
            <a:ext cx="4198056" cy="313399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B63FDB5-8515-C32F-CD7D-A906C3278BD0}"/>
              </a:ext>
            </a:extLst>
          </p:cNvPr>
          <p:cNvSpPr txBox="1"/>
          <p:nvPr/>
        </p:nvSpPr>
        <p:spPr>
          <a:xfrm>
            <a:off x="755150" y="1586917"/>
            <a:ext cx="515038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1E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Western blot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urine KPC parental cells, KRAS KO, STAT3 KO, multiple DKO cell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89BC293-1F99-4660-99D5-DE85B731D761}"/>
              </a:ext>
            </a:extLst>
          </p:cNvPr>
          <p:cNvSpPr txBox="1"/>
          <p:nvPr/>
        </p:nvSpPr>
        <p:spPr>
          <a:xfrm>
            <a:off x="4916145" y="3581213"/>
            <a:ext cx="7741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&lt; STAT3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B7BC5C7-AF61-2F6B-151C-2724E8447226}"/>
              </a:ext>
            </a:extLst>
          </p:cNvPr>
          <p:cNvSpPr txBox="1"/>
          <p:nvPr/>
        </p:nvSpPr>
        <p:spPr>
          <a:xfrm>
            <a:off x="4898063" y="4864989"/>
            <a:ext cx="7360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&lt; KRA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2C57946-E15A-8ACA-A926-A3BDEA67BAE6}"/>
              </a:ext>
            </a:extLst>
          </p:cNvPr>
          <p:cNvSpPr txBox="1"/>
          <p:nvPr/>
        </p:nvSpPr>
        <p:spPr>
          <a:xfrm>
            <a:off x="4895480" y="4118486"/>
            <a:ext cx="13227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&lt;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hosphoERK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26819427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6</Words>
  <Application>Microsoft Macintosh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ncy Reich Marshall</dc:creator>
  <cp:lastModifiedBy>Nancy Reich Marshall</cp:lastModifiedBy>
  <cp:revision>1</cp:revision>
  <dcterms:created xsi:type="dcterms:W3CDTF">2025-06-10T17:34:14Z</dcterms:created>
  <dcterms:modified xsi:type="dcterms:W3CDTF">2025-06-10T17:34:58Z</dcterms:modified>
</cp:coreProperties>
</file>